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CC636-0C48-4B06-BBCC-B7459B9E914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9269F-E27D-4DA8-A600-E96BB76DFF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DB043-FE82-4842-AE89-C095153C72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19076-8512-49E6-986C-8D083238D5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7CC587-41AD-4DC1-9A49-B3A680C18E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43AF41-F59A-4FA5-9AD2-1D28573B292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B58A4-2AD3-4436-B66A-2097C8BD6D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36A02-CAFB-4B6D-848F-8CC402132B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8DD421-EEBC-43CD-8AA6-A4779CA7FE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EB5085-F944-4B88-92D5-31289645FF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988C0A-6DD1-4AAC-9C90-A7C4F0D900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D8916-3D1D-4041-B687-83F6EA4B05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7153A3F-178A-4CBA-9430-4F1C7C8FC46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emporal dynamics of individual species and microbial pathways at each targeted body sit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1881360"/>
            <a:ext cx="4800600" cy="31240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J Lloyd-Price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6 (2017) doi:10.1038/nature2388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6T09:00:46Z</dcterms:created>
  <dc:creator>ravikumar.n</dc:creator>
  <dc:description/>
  <dc:language>en-US</dc:language>
  <cp:lastModifiedBy>ravikumar.n</cp:lastModifiedBy>
  <dcterms:modified xsi:type="dcterms:W3CDTF">2017-09-16T09:00:51Z</dcterms:modified>
  <cp:revision>1</cp:revision>
  <dc:subject/>
  <dc:title>Temporal dynamics of individual species and microbial pathways at each targeted body site</dc:title>
</cp:coreProperties>
</file>